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54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2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723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61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8253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731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723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110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121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7043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525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2160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747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4C77F-B568-481F-939B-C9293744BC15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22E82-A623-4F57-BEE0-DCE1C763B4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038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F1AD8F5-6503-4D8D-8CFA-D2C5490004B2}"/>
              </a:ext>
            </a:extLst>
          </p:cNvPr>
          <p:cNvSpPr txBox="1"/>
          <p:nvPr/>
        </p:nvSpPr>
        <p:spPr>
          <a:xfrm>
            <a:off x="3152776" y="5535736"/>
            <a:ext cx="36480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Figure S3. Oba et al. 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44F5037-B0D9-70F2-77B6-290204FB49AF}"/>
              </a:ext>
            </a:extLst>
          </p:cNvPr>
          <p:cNvSpPr/>
          <p:nvPr/>
        </p:nvSpPr>
        <p:spPr>
          <a:xfrm>
            <a:off x="60249" y="5860531"/>
            <a:ext cx="984575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aa the head of fiber protein sequences of PAdV-5 Ino5, PAdV-5 HNF-61 (AF186621), PAdV-5 HNF-70 (AF289262), PAdV-5VIRES_HuN02_C7 (MK377456), PAdV-5 VIRES_YN01_C10 (MK377469) (A). Structure prediction of partial fiber protein including the head region of PAdV-5 Ino5, PAdV-5 HNF-61, PAdV-5 HNF-70, PAdV-5VIRES_HuN02_C7, PAdV-5 VIRES_YN01_C10, porcine adenovirus 3 (AC_000189), and Human adenovirus 3 GB strain (AY599834) (B). The three-dimensional protein structures were predicted by Alphafold2 (https://colab.research.google.com/github/sokrypton/ColabFold/blob/main/AlphaFold2.ipynb) and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sualized using ChimeraX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A80C23D0-BC6E-9BF5-BAA2-0487ED1BFA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369" t="36974" r="20785" b="31524"/>
          <a:stretch/>
        </p:blipFill>
        <p:spPr>
          <a:xfrm>
            <a:off x="7236294" y="3429000"/>
            <a:ext cx="1920059" cy="2147073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AAA50F48-B603-0475-8C4D-1B1D542D204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670" t="22234" r="19781" b="31013"/>
          <a:stretch/>
        </p:blipFill>
        <p:spPr>
          <a:xfrm>
            <a:off x="7236294" y="1316055"/>
            <a:ext cx="1920058" cy="2050083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9EF17685-4C98-252B-22AB-C9181927430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208" t="14399" r="38584" b="28191"/>
          <a:stretch/>
        </p:blipFill>
        <p:spPr>
          <a:xfrm>
            <a:off x="4857471" y="1316055"/>
            <a:ext cx="2168513" cy="2517392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A5D7EEA1-A536-3583-7305-0B78A689A5F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631" t="29879" r="59825" b="12710"/>
          <a:stretch/>
        </p:blipFill>
        <p:spPr>
          <a:xfrm>
            <a:off x="2988971" y="1316056"/>
            <a:ext cx="1826117" cy="2517392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CCDC77F3-E415-6B07-9C73-0A866ECC8B5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9879" r="79451" b="12710"/>
          <a:stretch/>
        </p:blipFill>
        <p:spPr>
          <a:xfrm>
            <a:off x="1031269" y="1316056"/>
            <a:ext cx="1920059" cy="251739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6CBC221-1E39-47E4-B0B2-594A0684F263}"/>
              </a:ext>
            </a:extLst>
          </p:cNvPr>
          <p:cNvSpPr txBox="1"/>
          <p:nvPr/>
        </p:nvSpPr>
        <p:spPr>
          <a:xfrm>
            <a:off x="1120875" y="1316056"/>
            <a:ext cx="9929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V-5</a:t>
            </a:r>
          </a:p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o5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F411455-E306-43A8-8792-35023040632C}"/>
              </a:ext>
            </a:extLst>
          </p:cNvPr>
          <p:cNvSpPr txBox="1"/>
          <p:nvPr/>
        </p:nvSpPr>
        <p:spPr>
          <a:xfrm>
            <a:off x="3080770" y="1316056"/>
            <a:ext cx="1196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V-5</a:t>
            </a:r>
          </a:p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F-61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C99E4FA-4081-4626-810A-D78506C5DD66}"/>
              </a:ext>
            </a:extLst>
          </p:cNvPr>
          <p:cNvSpPr txBox="1"/>
          <p:nvPr/>
        </p:nvSpPr>
        <p:spPr>
          <a:xfrm>
            <a:off x="5047523" y="1316056"/>
            <a:ext cx="1006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V-5</a:t>
            </a:r>
          </a:p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F-70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BF14AC3-8A1E-425F-AF26-D8508CB79315}"/>
              </a:ext>
            </a:extLst>
          </p:cNvPr>
          <p:cNvSpPr txBox="1"/>
          <p:nvPr/>
        </p:nvSpPr>
        <p:spPr>
          <a:xfrm>
            <a:off x="7232826" y="1536420"/>
            <a:ext cx="1146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V-3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A638CCD-9938-F093-25E7-9EEA1AE28993}"/>
              </a:ext>
            </a:extLst>
          </p:cNvPr>
          <p:cNvSpPr txBox="1"/>
          <p:nvPr/>
        </p:nvSpPr>
        <p:spPr>
          <a:xfrm>
            <a:off x="7257013" y="3440450"/>
            <a:ext cx="1532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AdV-3 GB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2732B7D0-5274-4115-9B72-2BDA2B3226F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379" t="44076" r="20677" b="41318"/>
          <a:stretch/>
        </p:blipFill>
        <p:spPr>
          <a:xfrm>
            <a:off x="1031269" y="3874745"/>
            <a:ext cx="3075674" cy="1691048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E56F4A1F-5A1E-4035-BE81-05E810DA7AE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8604" t="44076" r="7533" b="41318"/>
          <a:stretch/>
        </p:blipFill>
        <p:spPr>
          <a:xfrm>
            <a:off x="4194863" y="3885025"/>
            <a:ext cx="2853196" cy="1691048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B6F6F9F-B388-4DB8-99E3-62E699051D7E}"/>
              </a:ext>
            </a:extLst>
          </p:cNvPr>
          <p:cNvSpPr txBox="1"/>
          <p:nvPr/>
        </p:nvSpPr>
        <p:spPr>
          <a:xfrm>
            <a:off x="1120876" y="3871687"/>
            <a:ext cx="13506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V-5</a:t>
            </a:r>
          </a:p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ES_HuN02_C7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5B456D7-70F3-463A-A1F9-4C9EEE6BD131}"/>
              </a:ext>
            </a:extLst>
          </p:cNvPr>
          <p:cNvSpPr txBox="1"/>
          <p:nvPr/>
        </p:nvSpPr>
        <p:spPr>
          <a:xfrm>
            <a:off x="4168189" y="3899895"/>
            <a:ext cx="9929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V-5</a:t>
            </a:r>
          </a:p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ES_YN01_C10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A0A22B6-7EB5-4041-AF59-05C31C208B0B}"/>
              </a:ext>
            </a:extLst>
          </p:cNvPr>
          <p:cNvSpPr txBox="1"/>
          <p:nvPr/>
        </p:nvSpPr>
        <p:spPr>
          <a:xfrm>
            <a:off x="560709" y="288913"/>
            <a:ext cx="896272" cy="605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800"/>
              </a:lnSpc>
            </a:pP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AdV-5 Ino5</a:t>
            </a:r>
          </a:p>
          <a:p>
            <a:pPr>
              <a:lnSpc>
                <a:spcPts val="800"/>
              </a:lnSpc>
            </a:pP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AdV-5 HNF-61</a:t>
            </a:r>
          </a:p>
          <a:p>
            <a:pPr>
              <a:lnSpc>
                <a:spcPts val="800"/>
              </a:lnSpc>
            </a:pP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AdV-5 HNF-70</a:t>
            </a:r>
          </a:p>
          <a:p>
            <a:pPr>
              <a:lnSpc>
                <a:spcPts val="800"/>
              </a:lnSpc>
            </a:pP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AdV-5 HuN02</a:t>
            </a:r>
          </a:p>
          <a:p>
            <a:pPr>
              <a:lnSpc>
                <a:spcPts val="800"/>
              </a:lnSpc>
            </a:pP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AdV-5 YN01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FCCF45F-BB34-422E-820B-B48B50B410D8}"/>
              </a:ext>
            </a:extLst>
          </p:cNvPr>
          <p:cNvSpPr/>
          <p:nvPr/>
        </p:nvSpPr>
        <p:spPr>
          <a:xfrm>
            <a:off x="1330812" y="992038"/>
            <a:ext cx="5846357" cy="112143"/>
          </a:xfrm>
          <a:prstGeom prst="rect">
            <a:avLst/>
          </a:prstGeom>
          <a:solidFill>
            <a:srgbClr val="CC66FF"/>
          </a:solidFill>
          <a:ln>
            <a:solidFill>
              <a:srgbClr val="CC66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C4ACA28A-1334-45D6-A15C-7A8154A46AC3}"/>
              </a:ext>
            </a:extLst>
          </p:cNvPr>
          <p:cNvSpPr/>
          <p:nvPr/>
        </p:nvSpPr>
        <p:spPr>
          <a:xfrm>
            <a:off x="3080770" y="1046958"/>
            <a:ext cx="21685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ad of fiber protein regio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444BF12-0AA4-4B37-BB7C-A24ED2B3DD50}"/>
              </a:ext>
            </a:extLst>
          </p:cNvPr>
          <p:cNvSpPr txBox="1"/>
          <p:nvPr/>
        </p:nvSpPr>
        <p:spPr>
          <a:xfrm>
            <a:off x="1213712" y="783732"/>
            <a:ext cx="501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6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52BF3EA7-7CAF-44B9-91FC-CE10FB4E1CD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332" t="51935" r="2642" b="36918"/>
          <a:stretch/>
        </p:blipFill>
        <p:spPr>
          <a:xfrm>
            <a:off x="1330812" y="187738"/>
            <a:ext cx="5829106" cy="653056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E0EB08C-6EA7-4455-8CB8-A4E245B74073}"/>
              </a:ext>
            </a:extLst>
          </p:cNvPr>
          <p:cNvSpPr txBox="1"/>
          <p:nvPr/>
        </p:nvSpPr>
        <p:spPr>
          <a:xfrm>
            <a:off x="128687" y="0"/>
            <a:ext cx="5309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FDA0ECF-D4A1-4EC1-BAAB-7D88D3200857}"/>
              </a:ext>
            </a:extLst>
          </p:cNvPr>
          <p:cNvSpPr txBox="1"/>
          <p:nvPr/>
        </p:nvSpPr>
        <p:spPr>
          <a:xfrm>
            <a:off x="128686" y="1218716"/>
            <a:ext cx="5309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38A2E19-5DA8-4064-A86B-38D73DDF1E43}"/>
              </a:ext>
            </a:extLst>
          </p:cNvPr>
          <p:cNvSpPr txBox="1"/>
          <p:nvPr/>
        </p:nvSpPr>
        <p:spPr>
          <a:xfrm>
            <a:off x="3618791" y="788491"/>
            <a:ext cx="501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17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FC67F5C-9F2E-49A2-933D-A886993E515F}"/>
              </a:ext>
            </a:extLst>
          </p:cNvPr>
          <p:cNvSpPr txBox="1"/>
          <p:nvPr/>
        </p:nvSpPr>
        <p:spPr>
          <a:xfrm>
            <a:off x="6976371" y="788489"/>
            <a:ext cx="501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9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A5023D2E-A345-4382-BD9F-B0483F4D8C01}"/>
              </a:ext>
            </a:extLst>
          </p:cNvPr>
          <p:cNvCxnSpPr/>
          <p:nvPr/>
        </p:nvCxnSpPr>
        <p:spPr>
          <a:xfrm>
            <a:off x="3698005" y="820012"/>
            <a:ext cx="0" cy="1720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64606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4</TotalTime>
  <Words>187</Words>
  <Application>Microsoft Office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等线</vt:lpstr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井 誠</dc:creator>
  <cp:lastModifiedBy>MDPI</cp:lastModifiedBy>
  <cp:revision>26</cp:revision>
  <dcterms:created xsi:type="dcterms:W3CDTF">2022-09-08T09:12:00Z</dcterms:created>
  <dcterms:modified xsi:type="dcterms:W3CDTF">2022-10-29T11:01:31Z</dcterms:modified>
</cp:coreProperties>
</file>